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4"/>
  </p:sldMasterIdLst>
  <p:sldIdLst>
    <p:sldId id="256" r:id="rId5"/>
    <p:sldId id="261" r:id="rId6"/>
    <p:sldId id="258" r:id="rId7"/>
    <p:sldId id="260" r:id="rId8"/>
    <p:sldId id="257" r:id="rId9"/>
    <p:sldId id="259" r:id="rId10"/>
  </p:sldIdLst>
  <p:sldSz cx="8229600" cy="3657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4F4E328-186E-4A52-9193-08AEA56B11AA}" v="3" dt="2021-06-02T19:56:35.659"/>
    <p1510:client id="{F87129DF-506A-8443-87A0-D28D5FF442D7}" v="7" dt="2021-06-02T16:55:49.02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 varScale="1">
        <p:scale>
          <a:sx n="114" d="100"/>
          <a:sy n="114" d="100"/>
        </p:scale>
        <p:origin x="235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5/10/relationships/revisionInfo" Target="revisionInfo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598593"/>
            <a:ext cx="6172200" cy="1273387"/>
          </a:xfrm>
        </p:spPr>
        <p:txBody>
          <a:bodyPr anchor="b"/>
          <a:lstStyle>
            <a:lvl1pPr algn="ctr"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1921087"/>
            <a:ext cx="6172200" cy="883073"/>
          </a:xfrm>
        </p:spPr>
        <p:txBody>
          <a:bodyPr/>
          <a:lstStyle>
            <a:lvl1pPr marL="0" indent="0" algn="ctr">
              <a:buNone/>
              <a:defRPr sz="1280"/>
            </a:lvl1pPr>
            <a:lvl2pPr marL="243825" indent="0" algn="ctr">
              <a:buNone/>
              <a:defRPr sz="1067"/>
            </a:lvl2pPr>
            <a:lvl3pPr marL="487650" indent="0" algn="ctr">
              <a:buNone/>
              <a:defRPr sz="960"/>
            </a:lvl3pPr>
            <a:lvl4pPr marL="731474" indent="0" algn="ctr">
              <a:buNone/>
              <a:defRPr sz="853"/>
            </a:lvl4pPr>
            <a:lvl5pPr marL="975299" indent="0" algn="ctr">
              <a:buNone/>
              <a:defRPr sz="853"/>
            </a:lvl5pPr>
            <a:lvl6pPr marL="1219124" indent="0" algn="ctr">
              <a:buNone/>
              <a:defRPr sz="853"/>
            </a:lvl6pPr>
            <a:lvl7pPr marL="1462949" indent="0" algn="ctr">
              <a:buNone/>
              <a:defRPr sz="853"/>
            </a:lvl7pPr>
            <a:lvl8pPr marL="1706773" indent="0" algn="ctr">
              <a:buNone/>
              <a:defRPr sz="853"/>
            </a:lvl8pPr>
            <a:lvl9pPr marL="1950598" indent="0" algn="ctr">
              <a:buNone/>
              <a:defRPr sz="85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AF1E3-F23B-B441-9F40-D27A0A3C35A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A2967-5FB8-DB4A-A608-8FC7CB099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64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AF1E3-F23B-B441-9F40-D27A0A3C35A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A2967-5FB8-DB4A-A608-8FC7CB099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131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89307" y="194733"/>
            <a:ext cx="1774508" cy="309964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5785" y="194733"/>
            <a:ext cx="5220653" cy="309964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AF1E3-F23B-B441-9F40-D27A0A3C35A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A2967-5FB8-DB4A-A608-8FC7CB099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471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AF1E3-F23B-B441-9F40-D27A0A3C35A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A2967-5FB8-DB4A-A608-8FC7CB099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571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1499" y="911860"/>
            <a:ext cx="7098030" cy="152146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1499" y="2447714"/>
            <a:ext cx="7098030" cy="800100"/>
          </a:xfrm>
        </p:spPr>
        <p:txBody>
          <a:bodyPr/>
          <a:lstStyle>
            <a:lvl1pPr marL="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1pPr>
            <a:lvl2pPr marL="243825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2pPr>
            <a:lvl3pPr marL="48765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3pPr>
            <a:lvl4pPr marL="731474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4pPr>
            <a:lvl5pPr marL="975299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5pPr>
            <a:lvl6pPr marL="1219124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6pPr>
            <a:lvl7pPr marL="1462949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7pPr>
            <a:lvl8pPr marL="1706773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8pPr>
            <a:lvl9pPr marL="1950598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AF1E3-F23B-B441-9F40-D27A0A3C35A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A2967-5FB8-DB4A-A608-8FC7CB099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372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5785" y="973666"/>
            <a:ext cx="3497580" cy="23207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235" y="973666"/>
            <a:ext cx="3497580" cy="23207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AF1E3-F23B-B441-9F40-D27A0A3C35A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A2967-5FB8-DB4A-A608-8FC7CB099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0863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194734"/>
            <a:ext cx="7098030" cy="70696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857" y="896620"/>
            <a:ext cx="3481506" cy="439420"/>
          </a:xfrm>
        </p:spPr>
        <p:txBody>
          <a:bodyPr anchor="b"/>
          <a:lstStyle>
            <a:lvl1pPr marL="0" indent="0">
              <a:buNone/>
              <a:defRPr sz="1280" b="1"/>
            </a:lvl1pPr>
            <a:lvl2pPr marL="243825" indent="0">
              <a:buNone/>
              <a:defRPr sz="1067" b="1"/>
            </a:lvl2pPr>
            <a:lvl3pPr marL="487650" indent="0">
              <a:buNone/>
              <a:defRPr sz="960" b="1"/>
            </a:lvl3pPr>
            <a:lvl4pPr marL="731474" indent="0">
              <a:buNone/>
              <a:defRPr sz="853" b="1"/>
            </a:lvl4pPr>
            <a:lvl5pPr marL="975299" indent="0">
              <a:buNone/>
              <a:defRPr sz="853" b="1"/>
            </a:lvl5pPr>
            <a:lvl6pPr marL="1219124" indent="0">
              <a:buNone/>
              <a:defRPr sz="853" b="1"/>
            </a:lvl6pPr>
            <a:lvl7pPr marL="1462949" indent="0">
              <a:buNone/>
              <a:defRPr sz="853" b="1"/>
            </a:lvl7pPr>
            <a:lvl8pPr marL="1706773" indent="0">
              <a:buNone/>
              <a:defRPr sz="853" b="1"/>
            </a:lvl8pPr>
            <a:lvl9pPr marL="1950598" indent="0">
              <a:buNone/>
              <a:defRPr sz="85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6857" y="1336040"/>
            <a:ext cx="3481506" cy="19651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66235" y="896620"/>
            <a:ext cx="3498652" cy="439420"/>
          </a:xfrm>
        </p:spPr>
        <p:txBody>
          <a:bodyPr anchor="b"/>
          <a:lstStyle>
            <a:lvl1pPr marL="0" indent="0">
              <a:buNone/>
              <a:defRPr sz="1280" b="1"/>
            </a:lvl1pPr>
            <a:lvl2pPr marL="243825" indent="0">
              <a:buNone/>
              <a:defRPr sz="1067" b="1"/>
            </a:lvl2pPr>
            <a:lvl3pPr marL="487650" indent="0">
              <a:buNone/>
              <a:defRPr sz="960" b="1"/>
            </a:lvl3pPr>
            <a:lvl4pPr marL="731474" indent="0">
              <a:buNone/>
              <a:defRPr sz="853" b="1"/>
            </a:lvl4pPr>
            <a:lvl5pPr marL="975299" indent="0">
              <a:buNone/>
              <a:defRPr sz="853" b="1"/>
            </a:lvl5pPr>
            <a:lvl6pPr marL="1219124" indent="0">
              <a:buNone/>
              <a:defRPr sz="853" b="1"/>
            </a:lvl6pPr>
            <a:lvl7pPr marL="1462949" indent="0">
              <a:buNone/>
              <a:defRPr sz="853" b="1"/>
            </a:lvl7pPr>
            <a:lvl8pPr marL="1706773" indent="0">
              <a:buNone/>
              <a:defRPr sz="853" b="1"/>
            </a:lvl8pPr>
            <a:lvl9pPr marL="1950598" indent="0">
              <a:buNone/>
              <a:defRPr sz="85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66235" y="1336040"/>
            <a:ext cx="3498652" cy="19651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AF1E3-F23B-B441-9F40-D27A0A3C35A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A2967-5FB8-DB4A-A608-8FC7CB099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59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AF1E3-F23B-B441-9F40-D27A0A3C35A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A2967-5FB8-DB4A-A608-8FC7CB099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088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AF1E3-F23B-B441-9F40-D27A0A3C35A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A2967-5FB8-DB4A-A608-8FC7CB099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984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243840"/>
            <a:ext cx="2654260" cy="853440"/>
          </a:xfrm>
        </p:spPr>
        <p:txBody>
          <a:bodyPr anchor="b"/>
          <a:lstStyle>
            <a:lvl1pPr>
              <a:defRPr sz="170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98652" y="526627"/>
            <a:ext cx="4166235" cy="2599267"/>
          </a:xfrm>
        </p:spPr>
        <p:txBody>
          <a:bodyPr/>
          <a:lstStyle>
            <a:lvl1pPr>
              <a:defRPr sz="1707"/>
            </a:lvl1pPr>
            <a:lvl2pPr>
              <a:defRPr sz="1493"/>
            </a:lvl2pPr>
            <a:lvl3pPr>
              <a:defRPr sz="1280"/>
            </a:lvl3pPr>
            <a:lvl4pPr>
              <a:defRPr sz="1067"/>
            </a:lvl4pPr>
            <a:lvl5pPr>
              <a:defRPr sz="1067"/>
            </a:lvl5pPr>
            <a:lvl6pPr>
              <a:defRPr sz="1067"/>
            </a:lvl6pPr>
            <a:lvl7pPr>
              <a:defRPr sz="1067"/>
            </a:lvl7pPr>
            <a:lvl8pPr>
              <a:defRPr sz="1067"/>
            </a:lvl8pPr>
            <a:lvl9pPr>
              <a:defRPr sz="10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1097280"/>
            <a:ext cx="2654260" cy="2032847"/>
          </a:xfrm>
        </p:spPr>
        <p:txBody>
          <a:bodyPr/>
          <a:lstStyle>
            <a:lvl1pPr marL="0" indent="0">
              <a:buNone/>
              <a:defRPr sz="853"/>
            </a:lvl1pPr>
            <a:lvl2pPr marL="243825" indent="0">
              <a:buNone/>
              <a:defRPr sz="747"/>
            </a:lvl2pPr>
            <a:lvl3pPr marL="487650" indent="0">
              <a:buNone/>
              <a:defRPr sz="640"/>
            </a:lvl3pPr>
            <a:lvl4pPr marL="731474" indent="0">
              <a:buNone/>
              <a:defRPr sz="533"/>
            </a:lvl4pPr>
            <a:lvl5pPr marL="975299" indent="0">
              <a:buNone/>
              <a:defRPr sz="533"/>
            </a:lvl5pPr>
            <a:lvl6pPr marL="1219124" indent="0">
              <a:buNone/>
              <a:defRPr sz="533"/>
            </a:lvl6pPr>
            <a:lvl7pPr marL="1462949" indent="0">
              <a:buNone/>
              <a:defRPr sz="533"/>
            </a:lvl7pPr>
            <a:lvl8pPr marL="1706773" indent="0">
              <a:buNone/>
              <a:defRPr sz="533"/>
            </a:lvl8pPr>
            <a:lvl9pPr marL="1950598" indent="0">
              <a:buNone/>
              <a:defRPr sz="5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AF1E3-F23B-B441-9F40-D27A0A3C35A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A2967-5FB8-DB4A-A608-8FC7CB099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5300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243840"/>
            <a:ext cx="2654260" cy="853440"/>
          </a:xfrm>
        </p:spPr>
        <p:txBody>
          <a:bodyPr anchor="b"/>
          <a:lstStyle>
            <a:lvl1pPr>
              <a:defRPr sz="170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98652" y="526627"/>
            <a:ext cx="4166235" cy="2599267"/>
          </a:xfrm>
        </p:spPr>
        <p:txBody>
          <a:bodyPr anchor="t"/>
          <a:lstStyle>
            <a:lvl1pPr marL="0" indent="0">
              <a:buNone/>
              <a:defRPr sz="1707"/>
            </a:lvl1pPr>
            <a:lvl2pPr marL="243825" indent="0">
              <a:buNone/>
              <a:defRPr sz="1493"/>
            </a:lvl2pPr>
            <a:lvl3pPr marL="487650" indent="0">
              <a:buNone/>
              <a:defRPr sz="1280"/>
            </a:lvl3pPr>
            <a:lvl4pPr marL="731474" indent="0">
              <a:buNone/>
              <a:defRPr sz="1067"/>
            </a:lvl4pPr>
            <a:lvl5pPr marL="975299" indent="0">
              <a:buNone/>
              <a:defRPr sz="1067"/>
            </a:lvl5pPr>
            <a:lvl6pPr marL="1219124" indent="0">
              <a:buNone/>
              <a:defRPr sz="1067"/>
            </a:lvl6pPr>
            <a:lvl7pPr marL="1462949" indent="0">
              <a:buNone/>
              <a:defRPr sz="1067"/>
            </a:lvl7pPr>
            <a:lvl8pPr marL="1706773" indent="0">
              <a:buNone/>
              <a:defRPr sz="1067"/>
            </a:lvl8pPr>
            <a:lvl9pPr marL="1950598" indent="0">
              <a:buNone/>
              <a:defRPr sz="10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1097280"/>
            <a:ext cx="2654260" cy="2032847"/>
          </a:xfrm>
        </p:spPr>
        <p:txBody>
          <a:bodyPr/>
          <a:lstStyle>
            <a:lvl1pPr marL="0" indent="0">
              <a:buNone/>
              <a:defRPr sz="853"/>
            </a:lvl1pPr>
            <a:lvl2pPr marL="243825" indent="0">
              <a:buNone/>
              <a:defRPr sz="747"/>
            </a:lvl2pPr>
            <a:lvl3pPr marL="487650" indent="0">
              <a:buNone/>
              <a:defRPr sz="640"/>
            </a:lvl3pPr>
            <a:lvl4pPr marL="731474" indent="0">
              <a:buNone/>
              <a:defRPr sz="533"/>
            </a:lvl4pPr>
            <a:lvl5pPr marL="975299" indent="0">
              <a:buNone/>
              <a:defRPr sz="533"/>
            </a:lvl5pPr>
            <a:lvl6pPr marL="1219124" indent="0">
              <a:buNone/>
              <a:defRPr sz="533"/>
            </a:lvl6pPr>
            <a:lvl7pPr marL="1462949" indent="0">
              <a:buNone/>
              <a:defRPr sz="533"/>
            </a:lvl7pPr>
            <a:lvl8pPr marL="1706773" indent="0">
              <a:buNone/>
              <a:defRPr sz="533"/>
            </a:lvl8pPr>
            <a:lvl9pPr marL="1950598" indent="0">
              <a:buNone/>
              <a:defRPr sz="5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AF1E3-F23B-B441-9F40-D27A0A3C35A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A2967-5FB8-DB4A-A608-8FC7CB099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0797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5785" y="194734"/>
            <a:ext cx="7098030" cy="7069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5785" y="973666"/>
            <a:ext cx="7098030" cy="23207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5785" y="3390054"/>
            <a:ext cx="1851660" cy="1947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7AF1E3-F23B-B441-9F40-D27A0A3C35A5}" type="datetimeFigureOut">
              <a:rPr lang="en-US" smtClean="0"/>
              <a:t>6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6055" y="3390054"/>
            <a:ext cx="2777490" cy="1947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12155" y="3390054"/>
            <a:ext cx="1851660" cy="1947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FA2967-5FB8-DB4A-A608-8FC7CB099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39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87650" rtl="0" eaLnBrk="1" latinLnBrk="0" hangingPunct="1">
        <a:lnSpc>
          <a:spcPct val="90000"/>
        </a:lnSpc>
        <a:spcBef>
          <a:spcPct val="0"/>
        </a:spcBef>
        <a:buNone/>
        <a:defRPr sz="234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1912" indent="-121912" algn="l" defTabSz="48765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1493" kern="1200">
          <a:solidFill>
            <a:schemeClr val="tx1"/>
          </a:solidFill>
          <a:latin typeface="+mn-lt"/>
          <a:ea typeface="+mn-ea"/>
          <a:cs typeface="+mn-cs"/>
        </a:defRPr>
      </a:lvl1pPr>
      <a:lvl2pPr marL="365737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1280" kern="1200">
          <a:solidFill>
            <a:schemeClr val="tx1"/>
          </a:solidFill>
          <a:latin typeface="+mn-lt"/>
          <a:ea typeface="+mn-ea"/>
          <a:cs typeface="+mn-cs"/>
        </a:defRPr>
      </a:lvl2pPr>
      <a:lvl3pPr marL="609562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1067" kern="1200">
          <a:solidFill>
            <a:schemeClr val="tx1"/>
          </a:solidFill>
          <a:latin typeface="+mn-lt"/>
          <a:ea typeface="+mn-ea"/>
          <a:cs typeface="+mn-cs"/>
        </a:defRPr>
      </a:lvl3pPr>
      <a:lvl4pPr marL="853387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4pPr>
      <a:lvl5pPr marL="1097211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5pPr>
      <a:lvl6pPr marL="1341036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6pPr>
      <a:lvl7pPr marL="1584861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7pPr>
      <a:lvl8pPr marL="1828686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8pPr>
      <a:lvl9pPr marL="2072510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1pPr>
      <a:lvl2pPr marL="243825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2pPr>
      <a:lvl3pPr marL="487650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3pPr>
      <a:lvl4pPr marL="731474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4pPr>
      <a:lvl5pPr marL="975299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5pPr>
      <a:lvl6pPr marL="1219124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6pPr>
      <a:lvl7pPr marL="1462949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7pPr>
      <a:lvl8pPr marL="1706773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8pPr>
      <a:lvl9pPr marL="1950598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4D17CD2-34A4-1A49-A31A-9C79E3FF6A4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957"/>
          <a:stretch/>
        </p:blipFill>
        <p:spPr>
          <a:xfrm>
            <a:off x="1075934" y="103239"/>
            <a:ext cx="5995564" cy="65349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2F6A927-065A-C04B-81DD-BF572D58AF8A}"/>
              </a:ext>
            </a:extLst>
          </p:cNvPr>
          <p:cNvSpPr txBox="1"/>
          <p:nvPr/>
        </p:nvSpPr>
        <p:spPr>
          <a:xfrm>
            <a:off x="1504823" y="32169"/>
            <a:ext cx="751994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4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vbzip1_A_C</a:t>
            </a:r>
            <a:endParaRPr lang="en-US" sz="64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23260511-41D0-EF4C-A6D8-1D8002D54FC3}"/>
              </a:ext>
            </a:extLst>
          </p:cNvPr>
          <p:cNvCxnSpPr>
            <a:cxnSpLocks/>
            <a:stCxn id="7" idx="2"/>
          </p:cNvCxnSpPr>
          <p:nvPr/>
        </p:nvCxnSpPr>
        <p:spPr>
          <a:xfrm flipH="1">
            <a:off x="1727500" y="222990"/>
            <a:ext cx="153320" cy="107204"/>
          </a:xfrm>
          <a:prstGeom prst="straightConnector1">
            <a:avLst/>
          </a:prstGeom>
          <a:ln w="19050">
            <a:solidFill>
              <a:schemeClr val="bg1">
                <a:lumMod val="50000"/>
              </a:schemeClr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Picture 21" descr="Chart&#10;&#10;Description automatically generated with medium confidence">
            <a:extLst>
              <a:ext uri="{FF2B5EF4-FFF2-40B4-BE49-F238E27FC236}">
                <a16:creationId xmlns:a16="http://schemas.microsoft.com/office/drawing/2014/main" id="{D852C675-2405-E94D-9B90-FCF1A40813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7836" y="776415"/>
            <a:ext cx="6006329" cy="1224458"/>
          </a:xfrm>
          <a:prstGeom prst="rect">
            <a:avLst/>
          </a:prstGeom>
        </p:spPr>
      </p:pic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DEF17633-B0BC-F84E-B0E6-F3DAB2FD21D3}"/>
              </a:ext>
            </a:extLst>
          </p:cNvPr>
          <p:cNvCxnSpPr>
            <a:cxnSpLocks/>
          </p:cNvCxnSpPr>
          <p:nvPr/>
        </p:nvCxnSpPr>
        <p:spPr>
          <a:xfrm flipV="1">
            <a:off x="1589815" y="381815"/>
            <a:ext cx="137684" cy="551541"/>
          </a:xfrm>
          <a:prstGeom prst="straightConnector1">
            <a:avLst/>
          </a:prstGeom>
          <a:ln w="19050">
            <a:solidFill>
              <a:schemeClr val="bg1">
                <a:lumMod val="50000"/>
              </a:schemeClr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tangle 27">
            <a:extLst>
              <a:ext uri="{FF2B5EF4-FFF2-40B4-BE49-F238E27FC236}">
                <a16:creationId xmlns:a16="http://schemas.microsoft.com/office/drawing/2014/main" id="{9D693E08-D5F5-7B43-B693-C22D7936BFDE}"/>
              </a:ext>
            </a:extLst>
          </p:cNvPr>
          <p:cNvSpPr/>
          <p:nvPr/>
        </p:nvSpPr>
        <p:spPr>
          <a:xfrm>
            <a:off x="2980118" y="649410"/>
            <a:ext cx="2156360" cy="2400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6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ZIP</a:t>
            </a:r>
            <a:r>
              <a:rPr lang="en-US" sz="96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ranscription factor family protein</a:t>
            </a:r>
            <a:r>
              <a:rPr lang="en-US" sz="9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36" name="Right Brace 35">
            <a:extLst>
              <a:ext uri="{FF2B5EF4-FFF2-40B4-BE49-F238E27FC236}">
                <a16:creationId xmlns:a16="http://schemas.microsoft.com/office/drawing/2014/main" id="{7CB4801E-4E8E-1C46-9081-71785D846DD0}"/>
              </a:ext>
            </a:extLst>
          </p:cNvPr>
          <p:cNvSpPr/>
          <p:nvPr/>
        </p:nvSpPr>
        <p:spPr>
          <a:xfrm>
            <a:off x="1556016" y="1783174"/>
            <a:ext cx="89805" cy="140027"/>
          </a:xfrm>
          <a:prstGeom prst="rightBrace">
            <a:avLst/>
          </a:prstGeom>
          <a:ln w="190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96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2AA8713-3BD7-0F48-93FD-6CD24CA92B94}"/>
              </a:ext>
            </a:extLst>
          </p:cNvPr>
          <p:cNvSpPr txBox="1"/>
          <p:nvPr/>
        </p:nvSpPr>
        <p:spPr>
          <a:xfrm>
            <a:off x="1614718" y="1784817"/>
            <a:ext cx="923692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4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mature stop codon 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6E33318-7BDD-CB4B-8F99-EDDCD767C0BC}"/>
              </a:ext>
            </a:extLst>
          </p:cNvPr>
          <p:cNvSpPr txBox="1"/>
          <p:nvPr/>
        </p:nvSpPr>
        <p:spPr>
          <a:xfrm>
            <a:off x="233464" y="2663198"/>
            <a:ext cx="786433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on of the Phvul.005G124100 (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ZIP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andidate gene for the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c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u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us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omic Sequence of Phvul.005G124100 gene model (G19833 v2.1)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ttom)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prediction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ilico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Phvul.005G12410 showing premature stop codon due to the SNP marker Pvbzip1_A_C in Othello and Beryl which possess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c-u</a:t>
            </a:r>
            <a:r>
              <a:rPr lang="en-US" sz="14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D4351BD-2E0A-FB4F-8D25-E00A59D6F1E1}"/>
              </a:ext>
            </a:extLst>
          </p:cNvPr>
          <p:cNvSpPr txBox="1"/>
          <p:nvPr/>
        </p:nvSpPr>
        <p:spPr>
          <a:xfrm>
            <a:off x="3936460" y="1918799"/>
            <a:ext cx="587155" cy="2073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47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mains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89E7FAB9-325E-064D-90BD-6E95E75099CE}"/>
              </a:ext>
            </a:extLst>
          </p:cNvPr>
          <p:cNvCxnSpPr>
            <a:cxnSpLocks/>
            <a:stCxn id="42" idx="0"/>
          </p:cNvCxnSpPr>
          <p:nvPr/>
        </p:nvCxnSpPr>
        <p:spPr>
          <a:xfrm flipV="1">
            <a:off x="4230038" y="1704499"/>
            <a:ext cx="581249" cy="214300"/>
          </a:xfrm>
          <a:prstGeom prst="straightConnector1">
            <a:avLst/>
          </a:prstGeom>
          <a:ln w="19050">
            <a:solidFill>
              <a:schemeClr val="bg1">
                <a:lumMod val="50000"/>
              </a:schemeClr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9BB0558C-E3C8-2C41-8048-F9F254EED597}"/>
              </a:ext>
            </a:extLst>
          </p:cNvPr>
          <p:cNvCxnSpPr>
            <a:cxnSpLocks/>
            <a:stCxn id="42" idx="0"/>
          </p:cNvCxnSpPr>
          <p:nvPr/>
        </p:nvCxnSpPr>
        <p:spPr>
          <a:xfrm flipH="1" flipV="1">
            <a:off x="3793330" y="1803103"/>
            <a:ext cx="436708" cy="115696"/>
          </a:xfrm>
          <a:prstGeom prst="straightConnector1">
            <a:avLst/>
          </a:prstGeom>
          <a:ln w="19050">
            <a:solidFill>
              <a:schemeClr val="bg1">
                <a:lumMod val="50000"/>
              </a:schemeClr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ight Arrow 24">
            <a:extLst>
              <a:ext uri="{FF2B5EF4-FFF2-40B4-BE49-F238E27FC236}">
                <a16:creationId xmlns:a16="http://schemas.microsoft.com/office/drawing/2014/main" id="{CDE13933-E3F6-F74B-8742-E7E3BD2624B2}"/>
              </a:ext>
            </a:extLst>
          </p:cNvPr>
          <p:cNvSpPr/>
          <p:nvPr/>
        </p:nvSpPr>
        <p:spPr>
          <a:xfrm>
            <a:off x="1003065" y="2014451"/>
            <a:ext cx="135467" cy="89021"/>
          </a:xfrm>
          <a:prstGeom prst="rightArrow">
            <a:avLst/>
          </a:prstGeom>
          <a:solidFill>
            <a:schemeClr val="bg1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ight Arrow 25">
            <a:extLst>
              <a:ext uri="{FF2B5EF4-FFF2-40B4-BE49-F238E27FC236}">
                <a16:creationId xmlns:a16="http://schemas.microsoft.com/office/drawing/2014/main" id="{736458C2-1480-9648-99C6-7CC8269BD12B}"/>
              </a:ext>
            </a:extLst>
          </p:cNvPr>
          <p:cNvSpPr/>
          <p:nvPr/>
        </p:nvSpPr>
        <p:spPr>
          <a:xfrm>
            <a:off x="1003065" y="2180630"/>
            <a:ext cx="135467" cy="89021"/>
          </a:xfrm>
          <a:prstGeom prst="rightArrow">
            <a:avLst/>
          </a:prstGeom>
          <a:solidFill>
            <a:srgbClr val="FFFF00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Right Arrow 26">
            <a:extLst>
              <a:ext uri="{FF2B5EF4-FFF2-40B4-BE49-F238E27FC236}">
                <a16:creationId xmlns:a16="http://schemas.microsoft.com/office/drawing/2014/main" id="{8BA11EDE-9824-5F47-8231-2EA1DA472570}"/>
              </a:ext>
            </a:extLst>
          </p:cNvPr>
          <p:cNvSpPr/>
          <p:nvPr/>
        </p:nvSpPr>
        <p:spPr>
          <a:xfrm>
            <a:off x="1003065" y="2334296"/>
            <a:ext cx="135467" cy="89021"/>
          </a:xfrm>
          <a:prstGeom prst="rightArrow">
            <a:avLst/>
          </a:prstGeom>
          <a:solidFill>
            <a:srgbClr val="E84D31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F5460BA-AFCB-6146-AC66-E5F0CA0EAF6F}"/>
              </a:ext>
            </a:extLst>
          </p:cNvPr>
          <p:cNvSpPr txBox="1"/>
          <p:nvPr/>
        </p:nvSpPr>
        <p:spPr>
          <a:xfrm>
            <a:off x="1135239" y="1931550"/>
            <a:ext cx="6090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TR</a:t>
            </a:r>
            <a:endParaRPr lang="en-US" sz="1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E22C689-3B9D-894A-A414-BAB8113D1443}"/>
              </a:ext>
            </a:extLst>
          </p:cNvPr>
          <p:cNvSpPr txBox="1"/>
          <p:nvPr/>
        </p:nvSpPr>
        <p:spPr>
          <a:xfrm>
            <a:off x="1125851" y="2105209"/>
            <a:ext cx="4445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S</a:t>
            </a:r>
            <a:endParaRPr lang="en-US" sz="1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49E05BF-675E-7343-97D9-AD2B39301FC5}"/>
              </a:ext>
            </a:extLst>
          </p:cNvPr>
          <p:cNvSpPr txBox="1"/>
          <p:nvPr/>
        </p:nvSpPr>
        <p:spPr>
          <a:xfrm>
            <a:off x="1125851" y="2247702"/>
            <a:ext cx="23434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lified by PCR + Sanger sequencing</a:t>
            </a:r>
          </a:p>
        </p:txBody>
      </p:sp>
      <p:sp>
        <p:nvSpPr>
          <p:cNvPr id="32" name="Right Arrow 31">
            <a:extLst>
              <a:ext uri="{FF2B5EF4-FFF2-40B4-BE49-F238E27FC236}">
                <a16:creationId xmlns:a16="http://schemas.microsoft.com/office/drawing/2014/main" id="{D8DFC194-62A7-4741-BDFF-9ED8B5B23120}"/>
              </a:ext>
            </a:extLst>
          </p:cNvPr>
          <p:cNvSpPr/>
          <p:nvPr/>
        </p:nvSpPr>
        <p:spPr>
          <a:xfrm>
            <a:off x="999772" y="2498747"/>
            <a:ext cx="135467" cy="89021"/>
          </a:xfrm>
          <a:prstGeom prst="rightArrow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C7CD9DF-DFB1-C844-8AFF-AC0F79C9DB1D}"/>
              </a:ext>
            </a:extLst>
          </p:cNvPr>
          <p:cNvSpPr txBox="1"/>
          <p:nvPr/>
        </p:nvSpPr>
        <p:spPr>
          <a:xfrm>
            <a:off x="1125851" y="2433284"/>
            <a:ext cx="10399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en-US" sz="1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55850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2BF3BFF-FD66-1540-88CF-F255CE1E5EB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802"/>
          <a:stretch/>
        </p:blipFill>
        <p:spPr>
          <a:xfrm>
            <a:off x="1122503" y="637465"/>
            <a:ext cx="5865036" cy="751840"/>
          </a:xfrm>
          <a:prstGeom prst="rect">
            <a:avLst/>
          </a:prstGeom>
        </p:spPr>
      </p:pic>
      <p:sp>
        <p:nvSpPr>
          <p:cNvPr id="4" name="Right Arrow 3">
            <a:extLst>
              <a:ext uri="{FF2B5EF4-FFF2-40B4-BE49-F238E27FC236}">
                <a16:creationId xmlns:a16="http://schemas.microsoft.com/office/drawing/2014/main" id="{6FA3D67D-444F-6B48-8CF7-82C68A8F5811}"/>
              </a:ext>
            </a:extLst>
          </p:cNvPr>
          <p:cNvSpPr/>
          <p:nvPr/>
        </p:nvSpPr>
        <p:spPr>
          <a:xfrm>
            <a:off x="999717" y="1835442"/>
            <a:ext cx="135467" cy="89021"/>
          </a:xfrm>
          <a:prstGeom prst="rightArrow">
            <a:avLst/>
          </a:prstGeom>
          <a:solidFill>
            <a:schemeClr val="bg1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ight Arrow 4">
            <a:extLst>
              <a:ext uri="{FF2B5EF4-FFF2-40B4-BE49-F238E27FC236}">
                <a16:creationId xmlns:a16="http://schemas.microsoft.com/office/drawing/2014/main" id="{B0C76C34-88E0-CF4C-BCEA-56E05486D16B}"/>
              </a:ext>
            </a:extLst>
          </p:cNvPr>
          <p:cNvSpPr/>
          <p:nvPr/>
        </p:nvSpPr>
        <p:spPr>
          <a:xfrm>
            <a:off x="999717" y="2001621"/>
            <a:ext cx="135467" cy="89021"/>
          </a:xfrm>
          <a:prstGeom prst="rightArrow">
            <a:avLst/>
          </a:prstGeom>
          <a:solidFill>
            <a:srgbClr val="FFFF00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ight Arrow 5">
            <a:extLst>
              <a:ext uri="{FF2B5EF4-FFF2-40B4-BE49-F238E27FC236}">
                <a16:creationId xmlns:a16="http://schemas.microsoft.com/office/drawing/2014/main" id="{8B2F63ED-6236-2E44-BD57-F651719F376E}"/>
              </a:ext>
            </a:extLst>
          </p:cNvPr>
          <p:cNvSpPr/>
          <p:nvPr/>
        </p:nvSpPr>
        <p:spPr>
          <a:xfrm>
            <a:off x="999717" y="2155287"/>
            <a:ext cx="135467" cy="89021"/>
          </a:xfrm>
          <a:prstGeom prst="rightArrow">
            <a:avLst/>
          </a:prstGeom>
          <a:solidFill>
            <a:srgbClr val="E84D31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891660F-8EC9-2A45-AC07-85C43971A3CC}"/>
              </a:ext>
            </a:extLst>
          </p:cNvPr>
          <p:cNvSpPr txBox="1"/>
          <p:nvPr/>
        </p:nvSpPr>
        <p:spPr>
          <a:xfrm>
            <a:off x="1131891" y="1752541"/>
            <a:ext cx="6090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TR</a:t>
            </a:r>
            <a:endParaRPr lang="en-US" sz="1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400C95E-3EFC-B740-8E34-CA6338C5394E}"/>
              </a:ext>
            </a:extLst>
          </p:cNvPr>
          <p:cNvSpPr txBox="1"/>
          <p:nvPr/>
        </p:nvSpPr>
        <p:spPr>
          <a:xfrm>
            <a:off x="1122503" y="1926200"/>
            <a:ext cx="4445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S</a:t>
            </a:r>
            <a:endParaRPr lang="en-US" sz="1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F86FCE0-B887-FD44-A67B-1C062583D012}"/>
              </a:ext>
            </a:extLst>
          </p:cNvPr>
          <p:cNvSpPr txBox="1"/>
          <p:nvPr/>
        </p:nvSpPr>
        <p:spPr>
          <a:xfrm>
            <a:off x="1122503" y="2068693"/>
            <a:ext cx="23434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lified by PCR + Sanger sequencing</a:t>
            </a:r>
          </a:p>
        </p:txBody>
      </p:sp>
      <p:sp>
        <p:nvSpPr>
          <p:cNvPr id="10" name="Right Arrow 9">
            <a:extLst>
              <a:ext uri="{FF2B5EF4-FFF2-40B4-BE49-F238E27FC236}">
                <a16:creationId xmlns:a16="http://schemas.microsoft.com/office/drawing/2014/main" id="{F924A67D-E172-604F-B638-A39C73FF469F}"/>
              </a:ext>
            </a:extLst>
          </p:cNvPr>
          <p:cNvSpPr/>
          <p:nvPr/>
        </p:nvSpPr>
        <p:spPr>
          <a:xfrm>
            <a:off x="996424" y="2319738"/>
            <a:ext cx="135467" cy="89021"/>
          </a:xfrm>
          <a:prstGeom prst="rightArrow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9AB5661-BA0A-9445-BF09-43DB8F618ABD}"/>
              </a:ext>
            </a:extLst>
          </p:cNvPr>
          <p:cNvSpPr txBox="1"/>
          <p:nvPr/>
        </p:nvSpPr>
        <p:spPr>
          <a:xfrm>
            <a:off x="1122503" y="2254275"/>
            <a:ext cx="10399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en-US" sz="1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96FD685-3084-C34D-B6E2-5C7DC97C2435}"/>
              </a:ext>
            </a:extLst>
          </p:cNvPr>
          <p:cNvSpPr txBox="1"/>
          <p:nvPr/>
        </p:nvSpPr>
        <p:spPr>
          <a:xfrm>
            <a:off x="3993860" y="483244"/>
            <a:ext cx="753249" cy="2073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47" dirty="0">
                <a:latin typeface="Times New Roman" panose="02020603050405020304" pitchFamily="18" charset="0"/>
                <a:cs typeface="Times New Roman" panose="02020603050405020304" pitchFamily="18" charset="0"/>
              </a:rPr>
              <a:t>SBD5 SCAR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00C33AA-42A6-8A4C-8C46-3EE8C7D36FC1}"/>
              </a:ext>
            </a:extLst>
          </p:cNvPr>
          <p:cNvSpPr txBox="1"/>
          <p:nvPr/>
        </p:nvSpPr>
        <p:spPr>
          <a:xfrm>
            <a:off x="2791962" y="488578"/>
            <a:ext cx="753249" cy="2073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47" dirty="0">
                <a:latin typeface="Times New Roman" panose="02020603050405020304" pitchFamily="18" charset="0"/>
                <a:cs typeface="Times New Roman" panose="02020603050405020304" pitchFamily="18" charset="0"/>
              </a:rPr>
              <a:t>S03_4203361 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25D4DD1D-0D9A-EC4F-9FCE-F0C7980B71F1}"/>
              </a:ext>
            </a:extLst>
          </p:cNvPr>
          <p:cNvCxnSpPr>
            <a:cxnSpLocks/>
            <a:stCxn id="14" idx="2"/>
          </p:cNvCxnSpPr>
          <p:nvPr/>
        </p:nvCxnSpPr>
        <p:spPr>
          <a:xfrm flipH="1">
            <a:off x="3012021" y="695879"/>
            <a:ext cx="156566" cy="198581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88462C4D-A0BF-CD43-A5F7-2BBF4A2F56DD}"/>
              </a:ext>
            </a:extLst>
          </p:cNvPr>
          <p:cNvSpPr txBox="1"/>
          <p:nvPr/>
        </p:nvSpPr>
        <p:spPr>
          <a:xfrm>
            <a:off x="3282416" y="1336868"/>
            <a:ext cx="1757221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eptor-Like Kinase genes 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AA1DF30A-C68E-A243-B74A-F6844E8A30C3}"/>
              </a:ext>
            </a:extLst>
          </p:cNvPr>
          <p:cNvCxnSpPr>
            <a:cxnSpLocks/>
            <a:endCxn id="22" idx="0"/>
          </p:cNvCxnSpPr>
          <p:nvPr/>
        </p:nvCxnSpPr>
        <p:spPr>
          <a:xfrm>
            <a:off x="2679121" y="1171016"/>
            <a:ext cx="1481906" cy="165852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prstDash val="sysDash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373144E-5CAC-654F-B88C-C268D6E226A8}"/>
              </a:ext>
            </a:extLst>
          </p:cNvPr>
          <p:cNvCxnSpPr>
            <a:cxnSpLocks/>
            <a:endCxn id="22" idx="0"/>
          </p:cNvCxnSpPr>
          <p:nvPr/>
        </p:nvCxnSpPr>
        <p:spPr>
          <a:xfrm flipH="1">
            <a:off x="4161027" y="1171016"/>
            <a:ext cx="1328292" cy="165852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prstDash val="sysDash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Right Brace 33">
            <a:extLst>
              <a:ext uri="{FF2B5EF4-FFF2-40B4-BE49-F238E27FC236}">
                <a16:creationId xmlns:a16="http://schemas.microsoft.com/office/drawing/2014/main" id="{129A7311-3171-A245-AA89-3321D79F486E}"/>
              </a:ext>
            </a:extLst>
          </p:cNvPr>
          <p:cNvSpPr/>
          <p:nvPr/>
        </p:nvSpPr>
        <p:spPr>
          <a:xfrm rot="16200000">
            <a:off x="4205915" y="160714"/>
            <a:ext cx="173827" cy="1107970"/>
          </a:xfrm>
          <a:prstGeom prst="rightBrace">
            <a:avLst/>
          </a:prstGeom>
          <a:ln w="1270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9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39EA3E5-03CB-9A47-9CF4-46A36BB6983E}"/>
              </a:ext>
            </a:extLst>
          </p:cNvPr>
          <p:cNvSpPr txBox="1"/>
          <p:nvPr/>
        </p:nvSpPr>
        <p:spPr>
          <a:xfrm>
            <a:off x="486411" y="2729592"/>
            <a:ext cx="759405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on of the Phvul.003G038700  and Phvul.003G038800 (RLKs) candidate genes for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-1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. The SBD5 SCAR marker, located on Pv03 (4,204,236 – 4,205,565 bases), is linked to S03_4203361 SNP marker (this study). </a:t>
            </a:r>
          </a:p>
        </p:txBody>
      </p:sp>
    </p:spTree>
    <p:extLst>
      <p:ext uri="{BB962C8B-B14F-4D97-AF65-F5344CB8AC3E}">
        <p14:creationId xmlns:p14="http://schemas.microsoft.com/office/powerpoint/2010/main" val="8642912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DD00DFAD-1DCA-8046-A4DA-7591DF9C27A7}"/>
              </a:ext>
            </a:extLst>
          </p:cNvPr>
          <p:cNvSpPr/>
          <p:nvPr/>
        </p:nvSpPr>
        <p:spPr>
          <a:xfrm>
            <a:off x="352896" y="2949714"/>
            <a:ext cx="689096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vbzip1_A_C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 (ºC) =66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0EE9BD1A-B9B8-A644-B307-BF238DAAA981}"/>
              </a:ext>
            </a:extLst>
          </p:cNvPr>
          <p:cNvGrpSpPr/>
          <p:nvPr/>
        </p:nvGrpSpPr>
        <p:grpSpPr>
          <a:xfrm>
            <a:off x="476250" y="259504"/>
            <a:ext cx="7277100" cy="2413000"/>
            <a:chOff x="476250" y="979351"/>
            <a:chExt cx="7277100" cy="2413000"/>
          </a:xfrm>
        </p:grpSpPr>
        <p:pic>
          <p:nvPicPr>
            <p:cNvPr id="11" name="Picture 10" descr="Chart, line chart&#10;&#10;Description automatically generated">
              <a:extLst>
                <a:ext uri="{FF2B5EF4-FFF2-40B4-BE49-F238E27FC236}">
                  <a16:creationId xmlns:a16="http://schemas.microsoft.com/office/drawing/2014/main" id="{54B6786C-BD65-0F4C-AD2A-9622E96DE39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76250" y="979351"/>
              <a:ext cx="7277100" cy="241300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63608ED-4D99-154B-A72D-AC096CF6D70A}"/>
                </a:ext>
              </a:extLst>
            </p:cNvPr>
            <p:cNvSpPr txBox="1"/>
            <p:nvPr/>
          </p:nvSpPr>
          <p:spPr>
            <a:xfrm>
              <a:off x="3030583" y="1368685"/>
              <a:ext cx="114517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-u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[AA]</a:t>
              </a:r>
            </a:p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ryl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00C3DBA-6F46-1047-A071-2320CE6DEEEF}"/>
                </a:ext>
              </a:extLst>
            </p:cNvPr>
            <p:cNvSpPr txBox="1"/>
            <p:nvPr/>
          </p:nvSpPr>
          <p:spPr>
            <a:xfrm>
              <a:off x="5547456" y="1368685"/>
              <a:ext cx="1550290" cy="6668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-u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 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[CC]</a:t>
              </a:r>
            </a:p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tter Pink </a:t>
              </a:r>
            </a:p>
            <a:p>
              <a:endPara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DE3B1E31-4970-534D-9343-F7C6B15569C6}"/>
                </a:ext>
              </a:extLst>
            </p:cNvPr>
            <p:cNvCxnSpPr/>
            <p:nvPr/>
          </p:nvCxnSpPr>
          <p:spPr>
            <a:xfrm flipH="1">
              <a:off x="4325896" y="1446336"/>
              <a:ext cx="0" cy="1737360"/>
            </a:xfrm>
            <a:prstGeom prst="line">
              <a:avLst/>
            </a:prstGeom>
            <a:ln w="12700">
              <a:solidFill>
                <a:schemeClr val="bg1">
                  <a:lumMod val="8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922CB87B-7F70-824D-AFB5-C3AC1656F62D}"/>
                </a:ext>
              </a:extLst>
            </p:cNvPr>
            <p:cNvCxnSpPr/>
            <p:nvPr/>
          </p:nvCxnSpPr>
          <p:spPr>
            <a:xfrm flipH="1">
              <a:off x="5392696" y="1729364"/>
              <a:ext cx="0" cy="1463040"/>
            </a:xfrm>
            <a:prstGeom prst="line">
              <a:avLst/>
            </a:prstGeom>
            <a:ln w="12700">
              <a:solidFill>
                <a:schemeClr val="bg1">
                  <a:lumMod val="8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228654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3DC4AC07-5018-B94D-B889-2967961A4C21}"/>
              </a:ext>
            </a:extLst>
          </p:cNvPr>
          <p:cNvSpPr/>
          <p:nvPr/>
        </p:nvSpPr>
        <p:spPr>
          <a:xfrm>
            <a:off x="346411" y="2949714"/>
            <a:ext cx="326208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03_4203361 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 (ºC) =69</a:t>
            </a:r>
          </a:p>
        </p:txBody>
      </p:sp>
      <p:pic>
        <p:nvPicPr>
          <p:cNvPr id="9" name="Picture 8" descr="Chart, line chart&#10;&#10;Description automatically generated">
            <a:extLst>
              <a:ext uri="{FF2B5EF4-FFF2-40B4-BE49-F238E27FC236}">
                <a16:creationId xmlns:a16="http://schemas.microsoft.com/office/drawing/2014/main" id="{3F8BD1F1-93D4-2C4C-9CBA-114D8FECB3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2600" y="354743"/>
            <a:ext cx="7264400" cy="2413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59C8329-F816-C444-98E3-04E7F8759761}"/>
              </a:ext>
            </a:extLst>
          </p:cNvPr>
          <p:cNvSpPr txBox="1"/>
          <p:nvPr/>
        </p:nvSpPr>
        <p:spPr>
          <a:xfrm>
            <a:off x="2449975" y="828014"/>
            <a:ext cx="108570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-1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[TT]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ry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E9DCE1E-0578-CA4A-B421-5C2666D21E90}"/>
              </a:ext>
            </a:extLst>
          </p:cNvPr>
          <p:cNvSpPr txBox="1"/>
          <p:nvPr/>
        </p:nvSpPr>
        <p:spPr>
          <a:xfrm>
            <a:off x="4842596" y="828014"/>
            <a:ext cx="108570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-1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[AA]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tter Pink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987BD1AD-7078-AA43-A794-1DEDFF2A21F2}"/>
              </a:ext>
            </a:extLst>
          </p:cNvPr>
          <p:cNvCxnSpPr/>
          <p:nvPr/>
        </p:nvCxnSpPr>
        <p:spPr>
          <a:xfrm flipH="1">
            <a:off x="3664044" y="828014"/>
            <a:ext cx="0" cy="1737360"/>
          </a:xfrm>
          <a:prstGeom prst="line">
            <a:avLst/>
          </a:prstGeom>
          <a:ln w="12700"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7BE30A79-330F-7546-A00F-C73672F8987D}"/>
              </a:ext>
            </a:extLst>
          </p:cNvPr>
          <p:cNvCxnSpPr/>
          <p:nvPr/>
        </p:nvCxnSpPr>
        <p:spPr>
          <a:xfrm flipH="1">
            <a:off x="4574090" y="828014"/>
            <a:ext cx="0" cy="1737360"/>
          </a:xfrm>
          <a:prstGeom prst="line">
            <a:avLst/>
          </a:prstGeom>
          <a:ln w="12700"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573483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F5D03AA6-BA52-5B4B-A59B-FCBE24884099}"/>
              </a:ext>
            </a:extLst>
          </p:cNvPr>
          <p:cNvSpPr/>
          <p:nvPr/>
        </p:nvSpPr>
        <p:spPr>
          <a:xfrm>
            <a:off x="463145" y="2949714"/>
            <a:ext cx="477033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02_48908259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 (ºC) =58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A47F5A4F-C23D-A449-B2F1-CED1A5CDB035}"/>
              </a:ext>
            </a:extLst>
          </p:cNvPr>
          <p:cNvGrpSpPr/>
          <p:nvPr/>
        </p:nvGrpSpPr>
        <p:grpSpPr>
          <a:xfrm>
            <a:off x="463145" y="362996"/>
            <a:ext cx="7264400" cy="2413000"/>
            <a:chOff x="482600" y="992052"/>
            <a:chExt cx="7264400" cy="2413000"/>
          </a:xfrm>
        </p:grpSpPr>
        <p:pic>
          <p:nvPicPr>
            <p:cNvPr id="11" name="Picture 10" descr="Chart, line chart&#10;&#10;Description automatically generated">
              <a:extLst>
                <a:ext uri="{FF2B5EF4-FFF2-40B4-BE49-F238E27FC236}">
                  <a16:creationId xmlns:a16="http://schemas.microsoft.com/office/drawing/2014/main" id="{E905B2EE-9D6E-2143-AB2F-0AD2F81A9D2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82600" y="992052"/>
              <a:ext cx="7264400" cy="241300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696F3B0-33F8-D349-905E-68CB61614830}"/>
                </a:ext>
              </a:extLst>
            </p:cNvPr>
            <p:cNvSpPr txBox="1"/>
            <p:nvPr/>
          </p:nvSpPr>
          <p:spPr>
            <a:xfrm>
              <a:off x="2654609" y="1411502"/>
              <a:ext cx="110749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i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[AA]</a:t>
              </a:r>
            </a:p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tter Pink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47F3CEA-D471-E243-AE83-DB0F6E3B2E79}"/>
                </a:ext>
              </a:extLst>
            </p:cNvPr>
            <p:cNvSpPr txBox="1"/>
            <p:nvPr/>
          </p:nvSpPr>
          <p:spPr>
            <a:xfrm>
              <a:off x="5555850" y="1411502"/>
              <a:ext cx="81881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I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[TT]</a:t>
              </a:r>
            </a:p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ryl</a:t>
              </a: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D04CB94E-15A4-0E46-BB4C-9979A34E84FB}"/>
                </a:ext>
              </a:extLst>
            </p:cNvPr>
            <p:cNvCxnSpPr/>
            <p:nvPr/>
          </p:nvCxnSpPr>
          <p:spPr>
            <a:xfrm flipH="1">
              <a:off x="4151724" y="1411502"/>
              <a:ext cx="0" cy="1737360"/>
            </a:xfrm>
            <a:prstGeom prst="line">
              <a:avLst/>
            </a:prstGeom>
            <a:ln w="12700">
              <a:solidFill>
                <a:schemeClr val="bg1">
                  <a:lumMod val="8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1EBDCB0D-9117-F442-8030-E2996C51CB43}"/>
                </a:ext>
              </a:extLst>
            </p:cNvPr>
            <p:cNvCxnSpPr/>
            <p:nvPr/>
          </p:nvCxnSpPr>
          <p:spPr>
            <a:xfrm flipH="1">
              <a:off x="5200804" y="1559591"/>
              <a:ext cx="0" cy="1645920"/>
            </a:xfrm>
            <a:prstGeom prst="line">
              <a:avLst/>
            </a:prstGeom>
            <a:ln w="12700">
              <a:solidFill>
                <a:schemeClr val="bg1">
                  <a:lumMod val="8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3259326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CA2846DD-B26B-1041-B6DD-A4C933F982BA}"/>
              </a:ext>
            </a:extLst>
          </p:cNvPr>
          <p:cNvSpPr/>
          <p:nvPr/>
        </p:nvSpPr>
        <p:spPr>
          <a:xfrm>
            <a:off x="339927" y="2949714"/>
            <a:ext cx="510168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veIF4E1,3,4 _PveIF4E2 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 (ºC) =69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0B525CB1-247E-674C-99CF-3BCECDD7E917}"/>
              </a:ext>
            </a:extLst>
          </p:cNvPr>
          <p:cNvGrpSpPr/>
          <p:nvPr/>
        </p:nvGrpSpPr>
        <p:grpSpPr>
          <a:xfrm>
            <a:off x="417749" y="296376"/>
            <a:ext cx="7264400" cy="2413000"/>
            <a:chOff x="482600" y="996768"/>
            <a:chExt cx="7264400" cy="2413000"/>
          </a:xfrm>
        </p:grpSpPr>
        <p:pic>
          <p:nvPicPr>
            <p:cNvPr id="11" name="Picture 10" descr="Chart, line chart&#10;&#10;Description automatically generated">
              <a:extLst>
                <a:ext uri="{FF2B5EF4-FFF2-40B4-BE49-F238E27FC236}">
                  <a16:creationId xmlns:a16="http://schemas.microsoft.com/office/drawing/2014/main" id="{F268E9D6-59C9-3241-BD12-8CCDE70CB70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82600" y="996768"/>
              <a:ext cx="7264400" cy="241300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BC64DE6-3F89-2240-9510-47BA6726CDAD}"/>
                </a:ext>
              </a:extLst>
            </p:cNvPr>
            <p:cNvSpPr txBox="1"/>
            <p:nvPr/>
          </p:nvSpPr>
          <p:spPr>
            <a:xfrm>
              <a:off x="2865124" y="1597967"/>
              <a:ext cx="117565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-3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[AA]</a:t>
              </a:r>
            </a:p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tter Pink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F0D28EF-2608-C549-A2F9-5F2703F02A4A}"/>
                </a:ext>
              </a:extLst>
            </p:cNvPr>
            <p:cNvSpPr txBox="1"/>
            <p:nvPr/>
          </p:nvSpPr>
          <p:spPr>
            <a:xfrm>
              <a:off x="5851943" y="1597967"/>
              <a:ext cx="92613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-3 [GG]</a:t>
              </a:r>
            </a:p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VT-7214 </a:t>
              </a: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D4D6A317-C51E-9D41-9E83-400CAC63D391}"/>
                </a:ext>
              </a:extLst>
            </p:cNvPr>
            <p:cNvCxnSpPr/>
            <p:nvPr/>
          </p:nvCxnSpPr>
          <p:spPr>
            <a:xfrm flipH="1">
              <a:off x="4456524" y="1437628"/>
              <a:ext cx="0" cy="1737360"/>
            </a:xfrm>
            <a:prstGeom prst="line">
              <a:avLst/>
            </a:prstGeom>
            <a:ln w="12700">
              <a:solidFill>
                <a:schemeClr val="bg1">
                  <a:lumMod val="8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4C05903C-609B-7C4E-BAB4-103F252D8CD1}"/>
                </a:ext>
              </a:extLst>
            </p:cNvPr>
            <p:cNvCxnSpPr/>
            <p:nvPr/>
          </p:nvCxnSpPr>
          <p:spPr>
            <a:xfrm flipH="1">
              <a:off x="5584284" y="1894114"/>
              <a:ext cx="0" cy="1280160"/>
            </a:xfrm>
            <a:prstGeom prst="line">
              <a:avLst/>
            </a:prstGeom>
            <a:ln w="12700">
              <a:solidFill>
                <a:schemeClr val="bg1">
                  <a:lumMod val="8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1025328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6CBB18936664241898AFA562DE33D51" ma:contentTypeVersion="10" ma:contentTypeDescription="Create a new document." ma:contentTypeScope="" ma:versionID="29a893d60f0f5e215e75bf2076d3113f">
  <xsd:schema xmlns:xsd="http://www.w3.org/2001/XMLSchema" xmlns:xs="http://www.w3.org/2001/XMLSchema" xmlns:p="http://schemas.microsoft.com/office/2006/metadata/properties" xmlns:ns1="http://schemas.microsoft.com/sharepoint/v3" xmlns:ns3="8a6c5866-9aee-4860-be59-b94cbe1de0dc" targetNamespace="http://schemas.microsoft.com/office/2006/metadata/properties" ma:root="true" ma:fieldsID="1289e1e86b05a808fbd1a21ddbf31c60" ns1:_="" ns3:_="">
    <xsd:import namespace="http://schemas.microsoft.com/sharepoint/v3"/>
    <xsd:import namespace="8a6c5866-9aee-4860-be59-b94cbe1de0dc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1:_ip_UnifiedCompliancePolicyProperties" minOccurs="0"/>
                <xsd:element ref="ns1:_ip_UnifiedCompliancePolicyUIAc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6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17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a6c5866-9aee-4860-be59-b94cbe1de0d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Props1.xml><?xml version="1.0" encoding="utf-8"?>
<ds:datastoreItem xmlns:ds="http://schemas.openxmlformats.org/officeDocument/2006/customXml" ds:itemID="{01E0EC71-3272-4B26-B0C6-F623B4958C4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8a6c5866-9aee-4860-be59-b94cbe1de0d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7F3D4BCA-681E-41EA-B570-148819F63741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5363824E-8899-47EB-B44B-D55E666074AB}">
  <ds:schemaRefs>
    <ds:schemaRef ds:uri="http://purl.org/dc/dcmitype/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schemas.microsoft.com/office/2006/documentManagement/types"/>
    <ds:schemaRef ds:uri="http://schemas.microsoft.com/sharepoint/v3"/>
    <ds:schemaRef ds:uri="http://purl.org/dc/terms/"/>
    <ds:schemaRef ds:uri="http://schemas.openxmlformats.org/package/2006/metadata/core-properties"/>
    <ds:schemaRef ds:uri="8a6c5866-9aee-4860-be59-b94cbe1de0dc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5</TotalTime>
  <Words>238</Words>
  <Application>Microsoft Office PowerPoint</Application>
  <PresentationFormat>Custom</PresentationFormat>
  <Paragraphs>4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klas, Phil</cp:lastModifiedBy>
  <cp:revision>14</cp:revision>
  <dcterms:created xsi:type="dcterms:W3CDTF">2021-01-17T12:37:35Z</dcterms:created>
  <dcterms:modified xsi:type="dcterms:W3CDTF">2021-06-02T19:56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6CBB18936664241898AFA562DE33D51</vt:lpwstr>
  </property>
</Properties>
</file>